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</p:sldIdLst>
  <p:sldSz cx="990758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04"/>
    <p:restoredTop sz="94444"/>
  </p:normalViewPr>
  <p:slideViewPr>
    <p:cSldViewPr snapToGrid="0" snapToObjects="1">
      <p:cViewPr varScale="1">
        <p:scale>
          <a:sx n="99" d="100"/>
          <a:sy n="99" d="100"/>
        </p:scale>
        <p:origin x="15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3069" y="1122363"/>
            <a:ext cx="84214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449" y="3602038"/>
            <a:ext cx="743069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938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8695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90118" y="365125"/>
            <a:ext cx="2136324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147" y="365125"/>
            <a:ext cx="6285126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37723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18855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987" y="1709740"/>
            <a:ext cx="854529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987" y="4589465"/>
            <a:ext cx="854529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53027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147" y="1825625"/>
            <a:ext cx="4210725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5716" y="1825625"/>
            <a:ext cx="4210725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02497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437" y="365127"/>
            <a:ext cx="854529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438" y="1681163"/>
            <a:ext cx="419137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438" y="2505075"/>
            <a:ext cx="4191373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5717" y="1681163"/>
            <a:ext cx="421201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5717" y="2505075"/>
            <a:ext cx="4212015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5585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9081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31853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437" y="457200"/>
            <a:ext cx="31954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2016" y="987427"/>
            <a:ext cx="5015716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437" y="2057400"/>
            <a:ext cx="31954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658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437" y="457200"/>
            <a:ext cx="31954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2016" y="987427"/>
            <a:ext cx="5015716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437" y="2057400"/>
            <a:ext cx="31954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3145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147" y="365127"/>
            <a:ext cx="854529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147" y="1825625"/>
            <a:ext cx="854529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147" y="6356352"/>
            <a:ext cx="222920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889" y="6356352"/>
            <a:ext cx="334381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7234" y="6356352"/>
            <a:ext cx="222920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89832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38634AC-B4D3-1441-8122-4D9495D888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9989" y="723161"/>
            <a:ext cx="1218779" cy="117363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ADE2562-4B72-8449-8D85-ADE2E5FF38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34879" y="765615"/>
            <a:ext cx="971306" cy="993563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6BE7651B-8DB4-AD48-BEC8-B748AA403E68}"/>
              </a:ext>
            </a:extLst>
          </p:cNvPr>
          <p:cNvCxnSpPr>
            <a:cxnSpLocks/>
          </p:cNvCxnSpPr>
          <p:nvPr/>
        </p:nvCxnSpPr>
        <p:spPr>
          <a:xfrm flipV="1">
            <a:off x="5600375" y="761438"/>
            <a:ext cx="0" cy="998406"/>
          </a:xfrm>
          <a:prstGeom prst="line">
            <a:avLst/>
          </a:prstGeom>
          <a:ln w="12700">
            <a:solidFill>
              <a:srgbClr val="7979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61A44A20-2759-4A47-9316-1E6171CC0278}"/>
              </a:ext>
            </a:extLst>
          </p:cNvPr>
          <p:cNvSpPr txBox="1"/>
          <p:nvPr/>
        </p:nvSpPr>
        <p:spPr>
          <a:xfrm rot="16200000">
            <a:off x="5146884" y="1120486"/>
            <a:ext cx="703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797979"/>
                </a:solidFill>
              </a:rPr>
              <a:t>CD45RA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6ABB0EF0-B7DB-B147-BEBE-41C83A722460}"/>
              </a:ext>
            </a:extLst>
          </p:cNvPr>
          <p:cNvCxnSpPr>
            <a:cxnSpLocks/>
          </p:cNvCxnSpPr>
          <p:nvPr/>
        </p:nvCxnSpPr>
        <p:spPr>
          <a:xfrm>
            <a:off x="5625084" y="1770161"/>
            <a:ext cx="992838" cy="0"/>
          </a:xfrm>
          <a:prstGeom prst="line">
            <a:avLst/>
          </a:prstGeom>
          <a:ln w="12700">
            <a:solidFill>
              <a:srgbClr val="7979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97DD292-60F1-6942-BA91-9B40813173D7}"/>
              </a:ext>
            </a:extLst>
          </p:cNvPr>
          <p:cNvSpPr txBox="1"/>
          <p:nvPr/>
        </p:nvSpPr>
        <p:spPr>
          <a:xfrm>
            <a:off x="5857087" y="1726246"/>
            <a:ext cx="539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797979"/>
                </a:solidFill>
              </a:rPr>
              <a:t>CCR7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E952649-48DB-CD45-AC43-F87A99B6BCE6}"/>
              </a:ext>
            </a:extLst>
          </p:cNvPr>
          <p:cNvCxnSpPr/>
          <p:nvPr/>
        </p:nvCxnSpPr>
        <p:spPr>
          <a:xfrm>
            <a:off x="4847688" y="1236337"/>
            <a:ext cx="4487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369E6BD-C647-4C43-AB5F-B3A4DBF2EE08}"/>
              </a:ext>
            </a:extLst>
          </p:cNvPr>
          <p:cNvSpPr txBox="1"/>
          <p:nvPr/>
        </p:nvSpPr>
        <p:spPr>
          <a:xfrm>
            <a:off x="180304" y="167425"/>
            <a:ext cx="95690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/>
              <a:t>Supplementary Figure 2: </a:t>
            </a:r>
            <a:r>
              <a:rPr lang="en-AU" sz="900" dirty="0"/>
              <a:t>Grouped data (mean with SD) showing the proportion of CD4/8 T cell subsets within PD1</a:t>
            </a:r>
            <a:r>
              <a:rPr lang="en-AU" sz="900" baseline="30000" dirty="0"/>
              <a:t>-</a:t>
            </a:r>
            <a:r>
              <a:rPr lang="en-AU" sz="900" dirty="0"/>
              <a:t> (left) and PD1</a:t>
            </a:r>
            <a:r>
              <a:rPr lang="en-AU" sz="900" baseline="30000" dirty="0"/>
              <a:t>+</a:t>
            </a:r>
            <a:r>
              <a:rPr lang="en-AU" sz="900" dirty="0"/>
              <a:t> (right) events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1A97D2FA-247E-984A-924E-FE2747909B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42982" y="761438"/>
            <a:ext cx="992839" cy="992839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3E9707C-7761-404D-A763-3336798EAF20}"/>
              </a:ext>
            </a:extLst>
          </p:cNvPr>
          <p:cNvCxnSpPr>
            <a:cxnSpLocks/>
          </p:cNvCxnSpPr>
          <p:nvPr/>
        </p:nvCxnSpPr>
        <p:spPr>
          <a:xfrm flipV="1">
            <a:off x="2623732" y="769551"/>
            <a:ext cx="0" cy="998406"/>
          </a:xfrm>
          <a:prstGeom prst="line">
            <a:avLst/>
          </a:prstGeom>
          <a:ln w="12700">
            <a:solidFill>
              <a:srgbClr val="7979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E3ADA450-C7B8-AF48-AD7B-1B7F0CD76553}"/>
              </a:ext>
            </a:extLst>
          </p:cNvPr>
          <p:cNvSpPr txBox="1"/>
          <p:nvPr/>
        </p:nvSpPr>
        <p:spPr>
          <a:xfrm rot="16200000">
            <a:off x="2294000" y="1122277"/>
            <a:ext cx="438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797979"/>
                </a:solidFill>
              </a:rPr>
              <a:t>CD8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B6DB1AF-B0CB-484B-8E38-4C6F3283F027}"/>
              </a:ext>
            </a:extLst>
          </p:cNvPr>
          <p:cNvCxnSpPr>
            <a:cxnSpLocks/>
          </p:cNvCxnSpPr>
          <p:nvPr/>
        </p:nvCxnSpPr>
        <p:spPr>
          <a:xfrm>
            <a:off x="2648441" y="1778274"/>
            <a:ext cx="992838" cy="0"/>
          </a:xfrm>
          <a:prstGeom prst="line">
            <a:avLst/>
          </a:prstGeom>
          <a:ln w="12700">
            <a:solidFill>
              <a:srgbClr val="7979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C4A2BF3-723B-FA42-BF28-741C9D7CBE5A}"/>
              </a:ext>
            </a:extLst>
          </p:cNvPr>
          <p:cNvSpPr txBox="1"/>
          <p:nvPr/>
        </p:nvSpPr>
        <p:spPr>
          <a:xfrm>
            <a:off x="2915339" y="1759109"/>
            <a:ext cx="448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797979"/>
                </a:solidFill>
              </a:rPr>
              <a:t>CD4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2BEFAF9-27AF-644F-9E93-17D43FE365C6}"/>
              </a:ext>
            </a:extLst>
          </p:cNvPr>
          <p:cNvCxnSpPr/>
          <p:nvPr/>
        </p:nvCxnSpPr>
        <p:spPr>
          <a:xfrm>
            <a:off x="3439592" y="1248238"/>
            <a:ext cx="4487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5D9674BF-F2A5-674A-A6C9-A384B975D16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405674"/>
            <a:ext cx="9907588" cy="40536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7904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8</TotalTime>
  <Words>35</Words>
  <Application>Microsoft Macintosh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Cooke</dc:creator>
  <cp:lastModifiedBy>Rachel Cooke</cp:lastModifiedBy>
  <cp:revision>49</cp:revision>
  <dcterms:created xsi:type="dcterms:W3CDTF">2019-05-25T03:52:18Z</dcterms:created>
  <dcterms:modified xsi:type="dcterms:W3CDTF">2020-07-12T04:25:30Z</dcterms:modified>
</cp:coreProperties>
</file>